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4B6DD-F519-4737-97B2-DB0A4DE5A9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6C9E5-6A97-45EE-B082-B0EF26F16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8A7B5-A7EA-4453-ABDC-B47B7B108E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0FA07-7E7B-43A7-82B0-7B39E60B94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C2ED3-9D18-47A1-B0F8-1B3AB2A4BC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C12C4-495E-4926-8E85-0FCDC7AD5E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511CA-5705-4078-9FF3-7DF9B25602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77A67-402B-4DBC-BDB2-5D07E513BA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6C696-68F8-4D3E-8183-6080AD617A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B06CC-84C4-4B23-99F5-30802B1295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EEC0F-CC60-4512-A1E2-B7D651DC4C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614F5-9D78-436A-BACA-41B56A2E11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23A4152-DFB3-44CF-AF46-BC99D644C83A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4"/>
          <p:cNvGrpSpPr/>
          <p:nvPr/>
        </p:nvGrpSpPr>
        <p:grpSpPr>
          <a:xfrm>
            <a:off x="-33480" y="47520"/>
            <a:ext cx="7029720" cy="9096480"/>
            <a:chOff x="-33480" y="47520"/>
            <a:chExt cx="7029720" cy="9096480"/>
          </a:xfrm>
        </p:grpSpPr>
        <p:sp>
          <p:nvSpPr>
            <p:cNvPr id="42" name="CasellaDiTesto 20"/>
            <p:cNvSpPr/>
            <p:nvPr/>
          </p:nvSpPr>
          <p:spPr>
            <a:xfrm>
              <a:off x="-33480" y="47520"/>
              <a:ext cx="7029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gure S1. </a:t>
              </a:r>
              <a:r>
                <a:rPr b="1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ration, purity and stability of human Th clones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CasellaDiTesto 1"/>
            <p:cNvSpPr/>
            <p:nvPr/>
          </p:nvSpPr>
          <p:spPr>
            <a:xfrm>
              <a:off x="94680" y="4362120"/>
              <a:ext cx="24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Immagine 25" descr=""/>
            <p:cNvPicPr/>
            <p:nvPr/>
          </p:nvPicPr>
          <p:blipFill>
            <a:blip r:embed="rId1"/>
            <a:stretch/>
          </p:blipFill>
          <p:spPr>
            <a:xfrm>
              <a:off x="360" y="718200"/>
              <a:ext cx="5779440" cy="1780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Immagine 26" descr=""/>
            <p:cNvPicPr/>
            <p:nvPr/>
          </p:nvPicPr>
          <p:blipFill>
            <a:blip r:embed="rId2"/>
            <a:stretch/>
          </p:blipFill>
          <p:spPr>
            <a:xfrm>
              <a:off x="210600" y="2935440"/>
              <a:ext cx="145800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Immagine 28" descr=""/>
            <p:cNvPicPr/>
            <p:nvPr/>
          </p:nvPicPr>
          <p:blipFill>
            <a:blip r:embed="rId3"/>
            <a:stretch/>
          </p:blipFill>
          <p:spPr>
            <a:xfrm>
              <a:off x="3444480" y="2935440"/>
              <a:ext cx="145800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Immagine 29" descr=""/>
            <p:cNvPicPr/>
            <p:nvPr/>
          </p:nvPicPr>
          <p:blipFill>
            <a:blip r:embed="rId4"/>
            <a:stretch/>
          </p:blipFill>
          <p:spPr>
            <a:xfrm>
              <a:off x="1820520" y="2935440"/>
              <a:ext cx="145800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Immagine 30" descr=""/>
            <p:cNvPicPr/>
            <p:nvPr/>
          </p:nvPicPr>
          <p:blipFill>
            <a:blip r:embed="rId5"/>
            <a:stretch/>
          </p:blipFill>
          <p:spPr>
            <a:xfrm>
              <a:off x="5050800" y="2935440"/>
              <a:ext cx="145800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CasellaDiTesto 31"/>
            <p:cNvSpPr/>
            <p:nvPr/>
          </p:nvSpPr>
          <p:spPr>
            <a:xfrm>
              <a:off x="64080" y="2532600"/>
              <a:ext cx="29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CasellaDiTesto 32"/>
            <p:cNvSpPr/>
            <p:nvPr/>
          </p:nvSpPr>
          <p:spPr>
            <a:xfrm>
              <a:off x="13680" y="416880"/>
              <a:ext cx="44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CasellaDiTesto 33"/>
            <p:cNvSpPr/>
            <p:nvPr/>
          </p:nvSpPr>
          <p:spPr>
            <a:xfrm>
              <a:off x="746280" y="2696400"/>
              <a:ext cx="145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Th0 clo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CasellaDiTesto 34"/>
            <p:cNvSpPr/>
            <p:nvPr/>
          </p:nvSpPr>
          <p:spPr>
            <a:xfrm>
              <a:off x="2343240" y="2672280"/>
              <a:ext cx="145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Th1 clo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CasellaDiTesto 35"/>
            <p:cNvSpPr/>
            <p:nvPr/>
          </p:nvSpPr>
          <p:spPr>
            <a:xfrm>
              <a:off x="3883680" y="2693160"/>
              <a:ext cx="145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Th17 clo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CasellaDiTesto 36"/>
            <p:cNvSpPr/>
            <p:nvPr/>
          </p:nvSpPr>
          <p:spPr>
            <a:xfrm>
              <a:off x="5478840" y="2659680"/>
              <a:ext cx="145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Th1/17 clo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5" name="Immagine 2" descr=""/>
            <p:cNvPicPr/>
            <p:nvPr/>
          </p:nvPicPr>
          <p:blipFill>
            <a:blip r:embed="rId6"/>
            <a:stretch/>
          </p:blipFill>
          <p:spPr>
            <a:xfrm>
              <a:off x="114480" y="4731120"/>
              <a:ext cx="210096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Immagine 3" descr=""/>
            <p:cNvPicPr/>
            <p:nvPr/>
          </p:nvPicPr>
          <p:blipFill>
            <a:blip r:embed="rId7"/>
            <a:stretch/>
          </p:blipFill>
          <p:spPr>
            <a:xfrm>
              <a:off x="2129040" y="4731120"/>
              <a:ext cx="208116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Immagine 5" descr=""/>
            <p:cNvPicPr/>
            <p:nvPr/>
          </p:nvPicPr>
          <p:blipFill>
            <a:blip r:embed="rId8"/>
            <a:stretch/>
          </p:blipFill>
          <p:spPr>
            <a:xfrm>
              <a:off x="4210560" y="4731120"/>
              <a:ext cx="206172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Immagine 13" descr=""/>
            <p:cNvPicPr/>
            <p:nvPr/>
          </p:nvPicPr>
          <p:blipFill>
            <a:blip r:embed="rId9"/>
            <a:stretch/>
          </p:blipFill>
          <p:spPr>
            <a:xfrm>
              <a:off x="2122560" y="6309720"/>
              <a:ext cx="208764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Immagine 14" descr=""/>
            <p:cNvPicPr/>
            <p:nvPr/>
          </p:nvPicPr>
          <p:blipFill>
            <a:blip r:embed="rId10"/>
            <a:stretch/>
          </p:blipFill>
          <p:spPr>
            <a:xfrm>
              <a:off x="133920" y="6309720"/>
              <a:ext cx="208116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Immagine 15" descr=""/>
            <p:cNvPicPr/>
            <p:nvPr/>
          </p:nvPicPr>
          <p:blipFill>
            <a:blip r:embed="rId11"/>
            <a:stretch/>
          </p:blipFill>
          <p:spPr>
            <a:xfrm>
              <a:off x="4210560" y="6309720"/>
              <a:ext cx="207468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Immagine 16" descr=""/>
            <p:cNvPicPr/>
            <p:nvPr/>
          </p:nvPicPr>
          <p:blipFill>
            <a:blip r:embed="rId12"/>
            <a:stretch/>
          </p:blipFill>
          <p:spPr>
            <a:xfrm>
              <a:off x="133920" y="7704000"/>
              <a:ext cx="208764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Immagine 17" descr=""/>
            <p:cNvPicPr/>
            <p:nvPr/>
          </p:nvPicPr>
          <p:blipFill>
            <a:blip r:embed="rId13"/>
            <a:stretch/>
          </p:blipFill>
          <p:spPr>
            <a:xfrm>
              <a:off x="2129040" y="7704000"/>
              <a:ext cx="208764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Immagine 21" descr=""/>
            <p:cNvPicPr/>
            <p:nvPr/>
          </p:nvPicPr>
          <p:blipFill>
            <a:blip r:embed="rId14"/>
            <a:stretch/>
          </p:blipFill>
          <p:spPr>
            <a:xfrm>
              <a:off x="4217040" y="7703280"/>
              <a:ext cx="2061720" cy="1440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3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06T09:00:15Z</dcterms:created>
  <dc:creator>Elisabetta Volpe</dc:creator>
  <dc:description/>
  <dc:language>en-US</dc:language>
  <cp:lastModifiedBy>ravikumar.n</cp:lastModifiedBy>
  <cp:lastPrinted>2014-09-23T08:26:44Z</cp:lastPrinted>
  <dcterms:modified xsi:type="dcterms:W3CDTF">2015-04-16T17:06:56Z</dcterms:modified>
  <cp:revision>104</cp:revision>
  <dc:subject/>
  <dc:title>Presentazione di PowerPoint</dc:title>
</cp:coreProperties>
</file>